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538C7-9FA8-4494-A4F5-7A896EBA8AA7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3BCB-AA89-4B4A-9EE8-22AA6E992D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409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538C7-9FA8-4494-A4F5-7A896EBA8AA7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3BCB-AA89-4B4A-9EE8-22AA6E992D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407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538C7-9FA8-4494-A4F5-7A896EBA8AA7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3BCB-AA89-4B4A-9EE8-22AA6E992D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258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538C7-9FA8-4494-A4F5-7A896EBA8AA7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3BCB-AA89-4B4A-9EE8-22AA6E992D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898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538C7-9FA8-4494-A4F5-7A896EBA8AA7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3BCB-AA89-4B4A-9EE8-22AA6E992D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569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538C7-9FA8-4494-A4F5-7A896EBA8AA7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3BCB-AA89-4B4A-9EE8-22AA6E992D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200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538C7-9FA8-4494-A4F5-7A896EBA8AA7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3BCB-AA89-4B4A-9EE8-22AA6E992D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520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538C7-9FA8-4494-A4F5-7A896EBA8AA7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3BCB-AA89-4B4A-9EE8-22AA6E992D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690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538C7-9FA8-4494-A4F5-7A896EBA8AA7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3BCB-AA89-4B4A-9EE8-22AA6E992D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498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538C7-9FA8-4494-A4F5-7A896EBA8AA7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3BCB-AA89-4B4A-9EE8-22AA6E992D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245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538C7-9FA8-4494-A4F5-7A896EBA8AA7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53BCB-AA89-4B4A-9EE8-22AA6E992D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407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B538C7-9FA8-4494-A4F5-7A896EBA8AA7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C53BCB-AA89-4B4A-9EE8-22AA6E992D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346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04800" y="6858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4" name="Rectangle 3"/>
          <p:cNvSpPr/>
          <p:nvPr/>
        </p:nvSpPr>
        <p:spPr>
          <a:xfrm>
            <a:off x="76200" y="2438400"/>
            <a:ext cx="906780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lone B6</a:t>
            </a:r>
            <a:endParaRPr 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</a:t>
            </a:r>
            <a:r>
              <a:rPr lang="en-US" sz="8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GGGCGTGTGCCGCAT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CAAAGTGGTGCCCAACCCCTTCTCAGAGTCTGGGGGTGATATGAAAGAGTGGTACCACATTAAGTG</a:t>
            </a:r>
            <a:r>
              <a:rPr lang="en-US" sz="8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GTTTGAGAAACTGGAA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r>
              <a:rPr lang="en-US" sz="800" b="1" u="sng" dirty="0">
                <a:solidFill>
                  <a:srgbClr val="7030A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GTAAAG------------ATTGGCAAAGTGGTGCCCAACCCCTTCTCAGAGTCTGGGGGTGATATGAAAGAGTGGTACCACATTAAGTGCATGTTTG---------AAC	∆12+∆9</a:t>
            </a:r>
          </a:p>
          <a:p>
            <a:r>
              <a:rPr lang="en-US" sz="800" b="1" u="sng" dirty="0">
                <a:solidFill>
                  <a:srgbClr val="7030A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GTAAAG------------ATTGGCAAAGTGGTGCCCAACCCCTTCTCAGAGTCTGGGGGTGATATGAAAGAGTGGTACCACATTAAGTGCATGTTTG---------AAC	∆12+∆9</a:t>
            </a: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TAAAGGGCGTGT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GCCATTGGCAAAGTGGTGCCCAACCCCTTCTCAGAGTCTGGGGGTGATATGAAAGAGTGGTACCACATTAAGT---------------TGGAAC	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2+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∆15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TGTAAAGGGCGTGT--GCCATTGGCAAAGTGGTGCCCAACCCCTTCTCAGAGTCTGGGGGTGATATGAAAGAGTGGTACCACATTAAGTGCATGT---------TGGAAC	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2+∆9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TGTAAAGGGCGTGT--GCCATTGGCAAAGTGGTGCCCAACCCCTTCTCAGAGTCTGGGGGTGATATGAAAGAGTGGTACCACATTAAGTGCATGT---------TGGAAC	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2+∆9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TGTAAAGGGCGTGT--GCCATTGGCAAAGTGGTGCCCAACCCCTTCTCATAGTCTGGGGGTGATATGAAAGAGTGGTACCACATTAAGTGCATGT---------TGGAAC	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2+∆9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TGTAAAGGGCGTGT--GCCATTGGCAAAGTGGTGCCCAAACCCTTCTCATAATCTGGGGGTGATATGAAAGATTGGTACCACATTAAGTGCATGT---------TGGAAC	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2+∆9</a:t>
            </a: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T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CGCATTGGCAAAGTGGTGCCCAACCCCTTCTCAGAGTCTGGGGGTGATATGAAAGAGTGGTACCACATTAAGT---------------TGGAAC	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13+∆15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TGT-------------CGCATTGGCAAAGTGGTGCCCAACCCCTTCTCAGAGTCTGGGGGTGATATGAAAGAGTGGTACCACATTAAGT---------------TGGAAC	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13+∆15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TGT-------------CGCATTGGCAAAGTGGTGCCCAACCCCTTCTCAGAGTCTGGGGGTGATATGAAAGAGTGGTACCACATTAAGT---------------TGGAAC	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13+∆15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TGT-------------CGCATTGGCAAAGTGGTGCCCAACCCCTTCTCAGAGTCTGGGGGTGATATGAAAGAGTGGTACCACATTAAGT---------------TGGAAC	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13+∆15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TGT-------------CGCATTGGCAAAGTGGTGCCCAACCCCTTCTCAGAGTCTGGGGGTGATATGAAAGAGTGGTACCACATTAAGT---------------TGGAAC	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∆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13+∆15</a:t>
            </a:r>
          </a:p>
        </p:txBody>
      </p:sp>
    </p:spTree>
    <p:extLst>
      <p:ext uri="{BB962C8B-B14F-4D97-AF65-F5344CB8AC3E}">
        <p14:creationId xmlns:p14="http://schemas.microsoft.com/office/powerpoint/2010/main" val="1765404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15294" y="566202"/>
            <a:ext cx="9067800" cy="5632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lone A8</a:t>
            </a: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EX1  </a:t>
            </a:r>
            <a:r>
              <a:rPr lang="en-US" sz="8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GGGCGTGTGCCGCAT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CAAAGTGGTGCCCAACCCCTTCTCAGAGTCTGGGGGTGATATGAAAGAGTGGTACCACATTAAGTG</a:t>
            </a:r>
            <a:r>
              <a:rPr lang="en-US" sz="8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GTTTGAGAAACTGGAA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GGCTCGGGCCACCA</a:t>
            </a:r>
            <a:endParaRPr 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   TAAAGGGCGTGTGCC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GAACGGGCTCGGGCCACCA	∆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8</a:t>
            </a:r>
            <a:endParaRPr 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   TAAAGGGCGTGTGCC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GAACGGGCTCGGGCCACCA	∆88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   TAAAGGGCGTGTGCC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GAACGGGCTCGGGCCACCA	∆88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   TAAAGGGCGTGTGCC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GAACGGGCTCGGGCCACCA	∆88</a:t>
            </a: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#5   TAAAGGGCGTGTGCC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GAACGGGCTCGGGCCACCA	∆88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   TAAAG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------GAACGGGCTCGGGCCACCA	∆98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7   TAAAG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------GAACGGGCTCGGGCCACCA	∆98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   TAAAGGGCGTGT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GAACGGGCTCGGGCCACCA	∆92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   TAAAGGGCGTGT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GAACGGGCTCGGGCCACCA	∆92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  TAAAGGGCGTGT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GAACGGGCTCGGGCCACCA	∆92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  TAAAGGGCGTGT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GAACGGGCTCGGGCCACCA	∆92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lone D8</a:t>
            </a: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EX1   ATTG</a:t>
            </a:r>
            <a:r>
              <a:rPr lang="en-US" sz="8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GGGCGTGTGCCGCA</a:t>
            </a:r>
            <a:r>
              <a:rPr lang="en-US" sz="800" b="1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CAAAGTGGTGCCCAACCCCTTCTCAGAGTCTGGGGGTGATATGAAAGAGTGGTACCACATTAAGTG</a:t>
            </a:r>
            <a:r>
              <a:rPr lang="en-US" sz="8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GTTTGAGAAACTGGAA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GGCTCGGGCC</a:t>
            </a:r>
            <a:endParaRPr 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    ATTGTAAAGGGCGTGTGC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CGTTGGCAAAGTGGTGCCCAACCCCTTCTCAGAGTCTGGGGGTGATATGAAAGAGTGGTACCACATTAAGTGCATGTTTGA------GAAACGGGCTCGGGCC	∆2+∆6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    ATTGTA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CATTGGCAAAGTGGTGCCCAACCCCTTCTCAGAGTCTGGGGGTGATATGAAAGAGTGGTACCACAT---------------------GGAACGGGCTCGGGCC	∆14+∆21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    ATTGTC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AAGTGGTGCCCAACCCCTTCTCAGAGTCTGGGGGTGATATGAAAGAGTGGTACCACATTAAGTGCAT-------------GAACGGGCTCGGGCC	∆22+∆13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    ATTGTAAAGG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------AACGGGCTCGGGCC	∆98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    ATTGTAAAGGGCGTGT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GCAAAGTGGTGCCCAACCCCTTCTCAGAGTCTGGGGGTGATATGAAAGAGTGGTACCACATT--------------------GGAACGGGCTCGGGCC	∆8+∆20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    ATTGTAAAGGGCGTGT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GCAAAGTGGTGCCCAACCCCTTCTCAGAGTCTGGGGGTGATATGAAAGAGTGGTACCACATT--------------------GGAACGGGCTCGGGCC	∆8+∆20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7    ATTGTAAAGGGCGTGT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GCAAAGTGGTGCCCAACCCCTTCTCAGAGTCTGGGGGTGATATGAAAGAGTGGTACCACATT--------------------GGAACGGGCTCGGGCC	∆8+∆20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    ATTGTAAAGGGCGTGT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GCAAAGTGGTGCCCAACCCCTTCTCAGAGTCTGGGGGTGATATGAAAGAGTGGTACCACATT--------------------GGAACGGGCTCGGGCC	∆8+∆20</a:t>
            </a: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#9    ATTGTAAAGGGCGTGTGC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CATTGGCAAAGTGGTGCCCAACCCCTTCTCAGAGTCTGGGGG</a:t>
            </a:r>
            <a:r>
              <a:rPr lang="en-US" sz="8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ATGAAAGAGTGGTACCACATT--------------------G-AACGGGCTCGGGCC	</a:t>
            </a:r>
            <a:r>
              <a:rPr lang="en-US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er</a:t>
            </a:r>
            <a:endParaRPr 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   ATTGTAAAGGGCGTGTGC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CATTGGCAAAGTGGTGCCCAACCCCTTCTCAGAGTCTGGGGG</a:t>
            </a:r>
            <a:r>
              <a:rPr lang="en-US" sz="8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ATGAAAGAGTGGTACCACATT---------------------GAACGGGCTCGGGCC	</a:t>
            </a:r>
            <a:r>
              <a:rPr lang="en-US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er</a:t>
            </a:r>
            <a:endParaRPr 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   ATTGTACATT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GCTGAGTGGTGCCGATCCCCTTCTCCTACTCTGAGGGTGATATTAATGAGTGGTACCGCAT---------------------GGAACGGGCTCGGGCC	∆14+∆21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lone E9</a:t>
            </a:r>
          </a:p>
          <a:p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Ex1   GAAGATTG</a:t>
            </a:r>
            <a:r>
              <a:rPr lang="en-US" sz="8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AAGGGCGTGTGCCGCAT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CAAAGTGGTGCCCAACCCCTTCTCAGAGTCTGGGGGTGATATGAAAGAGTGGTACCACATTAAGTG</a:t>
            </a:r>
            <a:r>
              <a:rPr lang="en-US" sz="8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GTTTGAGAAACTGGAA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GGC</a:t>
            </a:r>
            <a:endParaRPr 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    GAAGATTGTAA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CATTGGCAAAGTGGTGCCCAACCCCTTCTCAGAGTCTGGGGGTGATA</a:t>
            </a:r>
            <a:r>
              <a:rPr lang="en-US" sz="8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AGAGTGGTACCACATTAAGTG--------------TGGAACGGGC	</a:t>
            </a:r>
            <a:r>
              <a:rPr lang="en-US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er</a:t>
            </a:r>
            <a:endParaRPr 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    GAAGATTGTAA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CATTGGCAAAGTGGTGCCCAACCCCTTCTCAGAGTCTGGGGGTGATA</a:t>
            </a:r>
            <a:r>
              <a:rPr lang="en-US" sz="8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AGAGTGGTACCACATTAAGTG--------------TGGAACGGGC	</a:t>
            </a:r>
            <a:r>
              <a:rPr lang="en-US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er</a:t>
            </a:r>
            <a:endParaRPr 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    GAAGATTGTAAAGGGCGTGT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AACGGGC	∆92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    GAAGATTGTAAAGGGCGTGT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AACGGGC	∆92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    GAAGATTGTAAAGGGCGTGT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AACGGGC	∆92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    GAAGATTGTAAAGGGCGTGTGC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CGGAACGGGC	∆88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7    GAAGATTGTAAAGGGCGTGTGCCC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GAACGGGC	∆88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    GAAGATTGTAAAGGGCGTGTGCCC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GAGCCGCC	∆88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    GAAGATTGTAAAGGGCGTGT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GAACGGGC	∆92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   GAAGATTGTAAAG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------GAACGGGC	∆98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   GAAGATTGTAAAGG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----------------------------------GAACGGGC	∆98</a:t>
            </a: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   GCAGATTGTAAAGGGCGTGTGC-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-CATTGGCAAAGTGGTGCCCAACCCCTTCTCAGAGTCTGGGGGTGATA</a:t>
            </a:r>
            <a:r>
              <a:rPr lang="en-US" sz="8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</a:t>
            </a:r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GGAGTGGTACCACATT---------------------GAACGGGC	</a:t>
            </a:r>
            <a:r>
              <a:rPr lang="en-US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er</a:t>
            </a:r>
            <a:endParaRPr 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800" dirty="0">
                <a:latin typeface="Courier New" panose="02070309020205020404" pitchFamily="49" charset="0"/>
                <a:cs typeface="Courier New" panose="02070309020205020404" pitchFamily="49" charset="0"/>
              </a:rPr>
              <a:t> </a:t>
            </a:r>
          </a:p>
          <a:p>
            <a:endParaRPr 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52400" y="10774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9283" y="640080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3 Fig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41856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304800"/>
            <a:ext cx="8982075" cy="63248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lone C1</a:t>
            </a:r>
          </a:p>
          <a:p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EX8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CGATGGTGAGCGAGTCC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TGCATAAGAAGGGGGACCACTTCAGCTACTTCAGCCG</a:t>
            </a:r>
            <a:r>
              <a:rPr lang="en-US" sz="9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GTCTCAAGCCTGTCCT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CACAAGGT</a:t>
            </a:r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AGTC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TCAAGCCTGTCCTGCCTCACAAGGT	∆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6</a:t>
            </a:r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   GAGATC</a:t>
            </a:r>
            <a:r>
              <a:rPr lang="en-US" sz="900" b="1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AGTC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TCAAGCCTGTCCTGCCTCACAAGGT	∆46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AGTC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TCAAGCCTGTCCTGCCTCACAAGGT	∆46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TCCAGGTGCATAAGAAGGGGGACCACTTCAGCTACTTCAGCCGCAG-CTCAAGCCTGTCCTGCCTCACAAGGT	∆10+∆1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TCCAGGTGCATAAGAAGGGGGACCACTTCAGCTACTTCAGCCGCAG-CTCAAGCCTGTCCTGCCTCACAAGGT	∆10+∆1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TCCAGGTGCATAAGAAGGGGGACCACTTCAGCTACTTCAGCCGCAG-CTCAAGCCTGTCCTGCCTCACAAGGT	∆10+∆1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7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TCCAGGTGCATAAGAAGGGGGACCACTTCAGCTACTTCAGCCGCAG-CTCAAGCCTGTCCTGCCTCACAAGGT	∆10+∆1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TCCAGGTGCATAAGAAGGGGGACCACTTCAGCTACTTCAGCCGCAG-CTCAAGCCTGTCCTGCCTCACAAGGT	∆10+∆1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TCCAGGTGCATAAGAAGGGGGACCACTTCAGCTACTTCAGCCGCAG-CTCAAGCCTGTCCTGCCTCACAAGGT	∆10+∆1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TCCAGGAGCATAAAAAGGTTGACCACTTCAGCTACTTCACCCGCAC-CTCAAGCCTGTCCTGCCTCACAAGGT	∆10+∆1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b="1" u="sng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GTGCATAAGAAGGGGGACCACTTCAGCTACTTCAGCCGCAG------------CCTGCCTCACAAGGT	</a:t>
            </a:r>
            <a:r>
              <a:rPr lang="en-US" sz="9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er</a:t>
            </a:r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b="1" u="sng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GTGCATAAGAAGGGGGACCACTTCAGCTACTTCAGCCGCAG------------CCTGCCTCACAAGGT	</a:t>
            </a:r>
            <a:r>
              <a:rPr lang="en-US" sz="9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er</a:t>
            </a:r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9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lone 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D1</a:t>
            </a:r>
          </a:p>
          <a:p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Ex8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CGATGGTGAGCGAGTCC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TGCATAAGAAGGGGGACCACTTCAGCTACTTCAGCCG</a:t>
            </a:r>
            <a:r>
              <a:rPr lang="en-US" sz="9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GTCTCAAGCCTGTCCT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CACAAGGT</a:t>
            </a:r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 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AGTCTCAAGCCTGTCCTGCCTCACAAGGT	∆46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 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AGTCTCAAGCCTGTCCTGCCTCACAAGGT	∆46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 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AGTCTCAAGCCTGTCTTGCCTCACAAGGT	∆46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 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TCCAGGTGCATAAGAAGGGGGACCACTTCAGCTACTTCAGCCGCAG-------------CTGCCTCACAAGGT	∆5+∆13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 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TCCAGGTGCATAAGAAGGGGGACCACTTCAGCTACTTCAGCCGCAGT---------GTCCTGCCTCACAAGGT	∆5+∆9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 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TCCAGGTGCATAAGAAGGGGGACCACTTCAGCTACTTCAGCCGCAGT---------GTCCTGCCTCACAAGGT	∆5+∆9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7 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TCCAGGTGCATAAGAAGGGGGACCACTTCAGCTACTTCAGCCGCAGT---------GTCCTGCCTCGCAAGGT	∆5+∆9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 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TCCAGGTGCATAAGAAGGGGGACCACTTCAGCTACTTCAGCCGCAGT---------GTCCTGCCTCACAAGGT	∆5+∆9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 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TCCAGGTGCATAAGAAGGGGGACCACTTCAGCTACTTCAGCCGCAG-------------CTGCCTCACAAGGT	∆3+∆13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CTGCGGCTGAAGTAGCTGAAGTGGTCCCCCTTCTTATGCACCTGGAG--------------------------CCTCACAAGGT 	∆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75+I47</a:t>
            </a:r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CTGCGGCTGAAGTAGCTGAAGTGGTCCCCCTTCTTATGCACCTGGAG--------------------------CCTCACAAGGT	∆75+I47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CTGCGGCTGAAGTAGCTGAAGTGGTCCCCCTTCTTATGCACCTGGAG--------------------------CCTCACAAGGT	∆75+I47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  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lone D4</a:t>
            </a:r>
          </a:p>
          <a:p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EX8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CGATGGTGAGCGAGTCC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TGCATAAGAAGGGGGACCACTTCAGCTACTTCAGCCG</a:t>
            </a:r>
            <a:r>
              <a:rPr lang="en-US" sz="9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GT</a:t>
            </a:r>
            <a:r>
              <a:rPr lang="en-US" sz="900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900" b="1" u="sng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CAAGCCTGTCCT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CTCACAAGGTA</a:t>
            </a:r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AG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CAGGTGCATAAGAAGGGGGACCACTTCAGCTACTTCAGCCGCAGTTCTCAAGCCTGTCCTGCCTCACAAGGTA	∆2+i1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AG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—-CAGGTGCATAAGAAGGGGGACCACTTCAGCTACTTCAGCCGCAGTTCTCAAGCCTGTCCTGCCTCACAAGGTA	∆2+i1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AG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CAGGTGCATAAGAAGGGGGACCACTTCAGCTACTTCAGCCGCAGT------GCCTGTCCTGCCTCAGAAGGTA	∆2+∆5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b="1" u="sng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GTGCATAAGAAGGGGGACCACTTCAGCTACTTCAGCCGCAG-------------CCTGCCTCACAAGGTA	</a:t>
            </a:r>
            <a:r>
              <a:rPr lang="en-US" sz="9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er</a:t>
            </a:r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5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TCCTGCCTCACAAGGTA	∆63+introni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TCCTGCCTCACAAGGTA	∆63+introni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7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TCCTGCCTCACAAGGTA	∆63+introni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8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-----------------TCCTGCCTCACAAGGTA	∆63+introni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9 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A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T-CTCAAGCCTGTCCTGCCTCACAAGGTA	∆47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0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A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T-CTCAAGCCTGTCCTGCCTCACAAGGTA	∆47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1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A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T-CTCAAGCCTGTCCTGCCTCACAAGGTA	∆47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#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12  GAGATC</a:t>
            </a:r>
            <a:r>
              <a:rPr lang="en-US" sz="900" b="1" u="sng" dirty="0" smtClean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G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TGGTGAGCGA-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------T-CTCAAGCCTGTCCTGCCTCACAAGGTA	∆</a:t>
            </a:r>
            <a:r>
              <a:rPr lang="en-US" sz="9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7</a:t>
            </a:r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76200" y="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89283" y="640080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3 Fig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330296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81000" y="53340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4453" y="1295400"/>
            <a:ext cx="2542147" cy="203686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6444734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S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16281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9</Words>
  <Application>Microsoft Office PowerPoint</Application>
  <PresentationFormat>On-screen Show (4:3)</PresentationFormat>
  <Paragraphs>10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ourier New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sha</dc:creator>
  <cp:lastModifiedBy>Misha</cp:lastModifiedBy>
  <cp:revision>4</cp:revision>
  <dcterms:created xsi:type="dcterms:W3CDTF">2015-08-05T17:59:36Z</dcterms:created>
  <dcterms:modified xsi:type="dcterms:W3CDTF">2016-03-03T23:30:29Z</dcterms:modified>
</cp:coreProperties>
</file>